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501" r:id="rId2"/>
  </p:sldIdLst>
  <p:sldSz cx="12192000" cy="6858000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1DEE231-F65B-8F99-7EF4-8F60D3ABAD45}" name="Radka Vozárová" initials="RV" userId="S::vozarova@ibpcz.onmicrosoft.com::10c7d2bb-9bf3-4821-8bce-ea4c90b92261" providerId="AD"/>
  <p188:author id="{94518BCE-C8DB-2C8B-4E15-DB5CED368DA5}" name="Jana Lunerová" initials="JL" userId="S::jana.luner@ibpcz.onmicrosoft.com::1ab8f279-02ea-4500-b1ed-a8eb64d2bf92" providerId="AD"/>
  <p188:author id="{79240FDB-A574-7C02-B575-3AE43C89DDE3}" name="Jana Lunerová" initials="JL" userId="Jana Lunerová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řední styl 2 – zvýraznění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8484" autoAdjust="0"/>
  </p:normalViewPr>
  <p:slideViewPr>
    <p:cSldViewPr snapToGrid="0">
      <p:cViewPr varScale="1">
        <p:scale>
          <a:sx n="91" d="100"/>
          <a:sy n="91" d="100"/>
        </p:scale>
        <p:origin x="122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záhlaví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BA6860-6347-4252-9D99-E3D3FE4643F7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4" name="Zástupný symbol pro obrázek snímku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/>
          </a:p>
        </p:txBody>
      </p:sp>
      <p:sp>
        <p:nvSpPr>
          <p:cNvPr id="5" name="Zástupný symbol pro poznámky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8AB7C7-A152-49A0-9654-7A02B150DC2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4457632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obrázek snímk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Zástupný symbol pro poznámky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cs-CZ" dirty="0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8AB7C7-A152-49A0-9654-7A02B150DC25}" type="slidenum">
              <a:rPr lang="cs-CZ" smtClean="0"/>
              <a:t>1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7912244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E49039CC-89C9-45CD-9B19-095FFCB4C7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Podnadpis 2">
            <a:extLst>
              <a:ext uri="{FF2B5EF4-FFF2-40B4-BE49-F238E27FC236}">
                <a16:creationId xmlns:a16="http://schemas.microsoft.com/office/drawing/2014/main" id="{52FA946B-59DC-4D0D-9019-11FA9BF2EC2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cs-CZ"/>
              <a:t>Kliknutím můžete upravit styl předlohy.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AC9F1B01-997A-4EAB-8C74-E997AB84F8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9D5993D0-DDC2-436B-B011-C467D9ABF2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857B0017-0284-4947-AFC5-3B8FF1815A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0397356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2492208B-13C3-4453-AE08-7769C8B3D9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symbol pro svislý text 2">
            <a:extLst>
              <a:ext uri="{FF2B5EF4-FFF2-40B4-BE49-F238E27FC236}">
                <a16:creationId xmlns:a16="http://schemas.microsoft.com/office/drawing/2014/main" id="{00FB78A7-C118-44E5-B2BE-C845752EE5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54D51294-C6F0-45B1-8D5A-9F21656128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8E0B8CBE-FB11-4DD5-8F65-D8B1CC71E9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8DE7B16B-E6C1-4CAE-9528-5D68A5D65F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025198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>
            <a:extLst>
              <a:ext uri="{FF2B5EF4-FFF2-40B4-BE49-F238E27FC236}">
                <a16:creationId xmlns:a16="http://schemas.microsoft.com/office/drawing/2014/main" id="{1728F8F3-C5DC-4F33-A4A2-497C3CAEB04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symbol pro svislý text 2">
            <a:extLst>
              <a:ext uri="{FF2B5EF4-FFF2-40B4-BE49-F238E27FC236}">
                <a16:creationId xmlns:a16="http://schemas.microsoft.com/office/drawing/2014/main" id="{D1E2B75A-0FE5-4A9F-A8F2-EF6CC2D455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1F8855EA-5644-4E71-B656-72250C98EB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0E4D3B26-FE5D-4C2A-838D-ED9F263DD1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AA787EB7-28ED-4EF2-AAA6-809CA43C1E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6463005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4A053A50-F42E-469C-A4DC-BB6C1159A1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993A34E6-07ED-44F0-85D6-71C1D838DE5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9099696C-446D-4500-8B26-FF027363DD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C3FB5056-D79E-4571-AE61-498BB8B457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38A45115-DFD7-4B36-86AF-A120A91B03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36275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oddíl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85D96BD8-307D-45DD-8E45-165B7D9AF3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054C7D9C-970D-4766-A87D-777DE950BD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BB70794D-2632-4E1B-8901-38C970CFD9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116A6357-1F34-45CB-B403-A734CB9D49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91D0CD83-3D69-4AEB-B78C-C54E37275E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2807919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9A0501AF-A84D-42EF-8493-0323C1D614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C542208A-477D-49CC-918C-442E4CDBE5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obsah 3">
            <a:extLst>
              <a:ext uri="{FF2B5EF4-FFF2-40B4-BE49-F238E27FC236}">
                <a16:creationId xmlns:a16="http://schemas.microsoft.com/office/drawing/2014/main" id="{33859FAA-BD81-44CD-B855-35A553E627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A4845196-3870-4EB0-B503-7E9D7C97B2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7A8083E4-881B-4E72-BFAC-CC3266E792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075926A8-FD85-4894-8B19-3DF72271E0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126044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23EFD6A1-62AE-40E1-ADDD-216B10DCB8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514144B3-12FC-4B30-9C86-04C0E043A8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Zástupný obsah 3">
            <a:extLst>
              <a:ext uri="{FF2B5EF4-FFF2-40B4-BE49-F238E27FC236}">
                <a16:creationId xmlns:a16="http://schemas.microsoft.com/office/drawing/2014/main" id="{131B6B39-A08C-4661-9009-AD7CFBB488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5" name="Zástupný text 4">
            <a:extLst>
              <a:ext uri="{FF2B5EF4-FFF2-40B4-BE49-F238E27FC236}">
                <a16:creationId xmlns:a16="http://schemas.microsoft.com/office/drawing/2014/main" id="{B609063B-0776-41BD-A429-CF79C0CB29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6" name="Zástupný obsah 5">
            <a:extLst>
              <a:ext uri="{FF2B5EF4-FFF2-40B4-BE49-F238E27FC236}">
                <a16:creationId xmlns:a16="http://schemas.microsoft.com/office/drawing/2014/main" id="{A5E447EA-76FC-4D0C-9A88-B3005845118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7" name="Zástupný symbol pro datum 6">
            <a:extLst>
              <a:ext uri="{FF2B5EF4-FFF2-40B4-BE49-F238E27FC236}">
                <a16:creationId xmlns:a16="http://schemas.microsoft.com/office/drawing/2014/main" id="{DF94230D-6436-419A-892E-A73F139FB4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8" name="Zástupný symbol pro zápatí 7">
            <a:extLst>
              <a:ext uri="{FF2B5EF4-FFF2-40B4-BE49-F238E27FC236}">
                <a16:creationId xmlns:a16="http://schemas.microsoft.com/office/drawing/2014/main" id="{D58F1ADE-6F21-4749-8CCF-FD935784D6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>
            <a:extLst>
              <a:ext uri="{FF2B5EF4-FFF2-40B4-BE49-F238E27FC236}">
                <a16:creationId xmlns:a16="http://schemas.microsoft.com/office/drawing/2014/main" id="{3F484B44-4739-4F7C-B351-24161B3BA6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1857989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Jenom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9D92114E-D6A1-4F66-AB6A-5B8F95DB2A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symbol pro datum 2">
            <a:extLst>
              <a:ext uri="{FF2B5EF4-FFF2-40B4-BE49-F238E27FC236}">
                <a16:creationId xmlns:a16="http://schemas.microsoft.com/office/drawing/2014/main" id="{1B6DE6C3-DBC0-4087-A08F-851D1A1983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4" name="Zástupný symbol pro zápatí 3">
            <a:extLst>
              <a:ext uri="{FF2B5EF4-FFF2-40B4-BE49-F238E27FC236}">
                <a16:creationId xmlns:a16="http://schemas.microsoft.com/office/drawing/2014/main" id="{52496DC8-E66D-4BEB-AF1E-7CDF334F0B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>
            <a:extLst>
              <a:ext uri="{FF2B5EF4-FFF2-40B4-BE49-F238E27FC236}">
                <a16:creationId xmlns:a16="http://schemas.microsoft.com/office/drawing/2014/main" id="{DFD09EEA-973C-4392-AF59-92A0C08475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1795671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>
            <a:extLst>
              <a:ext uri="{FF2B5EF4-FFF2-40B4-BE49-F238E27FC236}">
                <a16:creationId xmlns:a16="http://schemas.microsoft.com/office/drawing/2014/main" id="{8D9AF19E-D4E0-4D83-AD00-D0DFB405E1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3" name="Zástupný symbol pro zápatí 2">
            <a:extLst>
              <a:ext uri="{FF2B5EF4-FFF2-40B4-BE49-F238E27FC236}">
                <a16:creationId xmlns:a16="http://schemas.microsoft.com/office/drawing/2014/main" id="{72D447CD-18DA-4A2C-B77D-8CAEFEE918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>
            <a:extLst>
              <a:ext uri="{FF2B5EF4-FFF2-40B4-BE49-F238E27FC236}">
                <a16:creationId xmlns:a16="http://schemas.microsoft.com/office/drawing/2014/main" id="{F5D47266-9485-4357-B858-446D5D4890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588915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89D2B7B6-1C19-441D-97A7-74D102C513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F60C4C94-44C5-4C73-954E-E8C6DD0289D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text 3">
            <a:extLst>
              <a:ext uri="{FF2B5EF4-FFF2-40B4-BE49-F238E27FC236}">
                <a16:creationId xmlns:a16="http://schemas.microsoft.com/office/drawing/2014/main" id="{6EA008ED-5FC5-4516-80E3-1CA4A51834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2F6C7ABB-5449-4ABD-845D-8F9D01EBD3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D9E9EC48-6FB3-4460-9585-7BFA35CD61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552FE676-7FE8-4215-AF5C-E81E11489C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9728450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47948D46-7216-4856-A3F7-B35ACC90D4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Zástupný symbol obrázku 2">
            <a:extLst>
              <a:ext uri="{FF2B5EF4-FFF2-40B4-BE49-F238E27FC236}">
                <a16:creationId xmlns:a16="http://schemas.microsoft.com/office/drawing/2014/main" id="{9A7130B0-B409-4726-BBCE-2602465782E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s-CZ"/>
          </a:p>
        </p:txBody>
      </p:sp>
      <p:sp>
        <p:nvSpPr>
          <p:cNvPr id="4" name="Zástupný text 3">
            <a:extLst>
              <a:ext uri="{FF2B5EF4-FFF2-40B4-BE49-F238E27FC236}">
                <a16:creationId xmlns:a16="http://schemas.microsoft.com/office/drawing/2014/main" id="{BEBC048F-FC7F-48CE-B771-E867FB3F43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577E07ED-60F2-478D-82CC-2BD1DF8A4A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3649A336-6239-4A5C-89F9-2E6A1E196C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BD34E1B6-3095-4794-8320-AB486EE016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343160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nadpis 1">
            <a:extLst>
              <a:ext uri="{FF2B5EF4-FFF2-40B4-BE49-F238E27FC236}">
                <a16:creationId xmlns:a16="http://schemas.microsoft.com/office/drawing/2014/main" id="{EC7869CA-580F-48C5-9F96-03C7FD85BC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4C0EFDB0-0EB9-42FD-BE31-433B80F8D4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20FA9E4A-544F-4E58-A161-6AB14283248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851AB8EF-3D04-4F91-A146-BB50B545D1F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39EA0394-177C-486B-A4BB-3400A50B3D2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0701689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ovéPole 9">
            <a:extLst>
              <a:ext uri="{FF2B5EF4-FFF2-40B4-BE49-F238E27FC236}">
                <a16:creationId xmlns:a16="http://schemas.microsoft.com/office/drawing/2014/main" id="{5F9623D1-297D-F205-CB7C-F6728233CEC3}"/>
              </a:ext>
            </a:extLst>
          </p:cNvPr>
          <p:cNvSpPr txBox="1"/>
          <p:nvPr/>
        </p:nvSpPr>
        <p:spPr>
          <a:xfrm>
            <a:off x="112459" y="49133"/>
            <a:ext cx="1198429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kumimoji="0" lang="en-US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 Figure S</a:t>
            </a:r>
            <a:r>
              <a:rPr kumimoji="0" lang="cs-CZ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</a:t>
            </a:r>
            <a:r>
              <a:rPr kumimoji="0" lang="en-US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. </a:t>
            </a:r>
            <a:r>
              <a:rPr lang="en-GB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osa </a:t>
            </a:r>
            <a:r>
              <a:rPr lang="en-GB" i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ubiginosa</a:t>
            </a:r>
            <a:r>
              <a:rPr lang="en-GB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arly metaphase I </a:t>
            </a:r>
            <a:r>
              <a:rPr lang="en-GB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mmunostained</a:t>
            </a:r>
            <a:r>
              <a:rPr lang="en-GB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ith an antibody against H3S10p (A). Arrowheads – </a:t>
            </a:r>
            <a:r>
              <a:rPr lang="en-GB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nivalents</a:t>
            </a:r>
            <a:r>
              <a:rPr lang="en-GB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Arrows - bivalents.</a:t>
            </a:r>
            <a:r>
              <a:rPr lang="en-GB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r>
              <a:rPr lang="en-GB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ox plot diagrams of DAPI fluorescence intensity on bivalents (BIV) and </a:t>
            </a:r>
            <a:r>
              <a:rPr lang="en-GB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nivalents</a:t>
            </a:r>
            <a:r>
              <a:rPr lang="en-GB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UNI). “N“ is the number of counted chromosomes. Bar 10 µm.</a:t>
            </a:r>
            <a:endParaRPr lang="cs-CZ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2" name="Přímá spojnice se šipkou 1">
            <a:extLst>
              <a:ext uri="{FF2B5EF4-FFF2-40B4-BE49-F238E27FC236}">
                <a16:creationId xmlns:a16="http://schemas.microsoft.com/office/drawing/2014/main" id="{A084EA0E-9B21-9CB2-9C6D-00489525F70A}"/>
              </a:ext>
            </a:extLst>
          </p:cNvPr>
          <p:cNvCxnSpPr>
            <a:cxnSpLocks/>
          </p:cNvCxnSpPr>
          <p:nvPr/>
        </p:nvCxnSpPr>
        <p:spPr>
          <a:xfrm flipH="1">
            <a:off x="7805220" y="3494357"/>
            <a:ext cx="103869" cy="124074"/>
          </a:xfrm>
          <a:prstGeom prst="straightConnector1">
            <a:avLst/>
          </a:prstGeom>
          <a:ln w="76200">
            <a:solidFill>
              <a:schemeClr val="bg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" name="Obrázek 13" descr="Obsah obrázku text&#10;&#10;Popis byl vytvořen automaticky">
            <a:extLst>
              <a:ext uri="{FF2B5EF4-FFF2-40B4-BE49-F238E27FC236}">
                <a16:creationId xmlns:a16="http://schemas.microsoft.com/office/drawing/2014/main" id="{7179D516-3961-35C9-47A8-7BE06B985F9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7525"/>
          <a:stretch/>
        </p:blipFill>
        <p:spPr>
          <a:xfrm>
            <a:off x="688484" y="1195117"/>
            <a:ext cx="8988455" cy="2395808"/>
          </a:xfrm>
          <a:prstGeom prst="rect">
            <a:avLst/>
          </a:prstGeom>
        </p:spPr>
      </p:pic>
      <p:sp>
        <p:nvSpPr>
          <p:cNvPr id="3" name="TextovéPole 2">
            <a:extLst>
              <a:ext uri="{FF2B5EF4-FFF2-40B4-BE49-F238E27FC236}">
                <a16:creationId xmlns:a16="http://schemas.microsoft.com/office/drawing/2014/main" id="{BD83DC05-EC96-AACA-F460-AE8CE9429819}"/>
              </a:ext>
            </a:extLst>
          </p:cNvPr>
          <p:cNvSpPr txBox="1"/>
          <p:nvPr/>
        </p:nvSpPr>
        <p:spPr>
          <a:xfrm>
            <a:off x="688484" y="3934900"/>
            <a:ext cx="17244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dirty="0"/>
              <a:t>B</a:t>
            </a:r>
            <a:r>
              <a:rPr lang="cs-CZ" sz="1400" dirty="0"/>
              <a:t>     </a:t>
            </a:r>
            <a:r>
              <a:rPr lang="cs-CZ" sz="1400" i="1" dirty="0"/>
              <a:t>R. </a:t>
            </a:r>
            <a:r>
              <a:rPr lang="cs-CZ" sz="1400" i="1" dirty="0" err="1"/>
              <a:t>rubiginosa</a:t>
            </a:r>
            <a:r>
              <a:rPr lang="cs-CZ" sz="1400" i="1" dirty="0"/>
              <a:t> </a:t>
            </a:r>
            <a:r>
              <a:rPr lang="cs-CZ" sz="1400" dirty="0"/>
              <a:t>CZ </a:t>
            </a:r>
          </a:p>
        </p:txBody>
      </p:sp>
      <p:pic>
        <p:nvPicPr>
          <p:cNvPr id="5" name="Obrázek 4" descr="Obsah obrázku diagram, snímek obrazovky, text, skica&#10;&#10;Popis byl vytvořen automaticky">
            <a:extLst>
              <a:ext uri="{FF2B5EF4-FFF2-40B4-BE49-F238E27FC236}">
                <a16:creationId xmlns:a16="http://schemas.microsoft.com/office/drawing/2014/main" id="{98F5E5AC-6E8C-BF51-7638-30E089841A5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04" t="1090" r="5211" b="15448"/>
          <a:stretch/>
        </p:blipFill>
        <p:spPr>
          <a:xfrm>
            <a:off x="3885292" y="3886200"/>
            <a:ext cx="3919928" cy="2926424"/>
          </a:xfrm>
          <a:prstGeom prst="rect">
            <a:avLst/>
          </a:prstGeom>
        </p:spPr>
      </p:pic>
      <p:sp>
        <p:nvSpPr>
          <p:cNvPr id="6" name="TextovéPole 5">
            <a:extLst>
              <a:ext uri="{FF2B5EF4-FFF2-40B4-BE49-F238E27FC236}">
                <a16:creationId xmlns:a16="http://schemas.microsoft.com/office/drawing/2014/main" id="{C9C20CEC-1E4C-1E3B-662E-5514C92E2573}"/>
              </a:ext>
            </a:extLst>
          </p:cNvPr>
          <p:cNvSpPr txBox="1"/>
          <p:nvPr/>
        </p:nvSpPr>
        <p:spPr>
          <a:xfrm rot="16200000">
            <a:off x="2851997" y="5111287"/>
            <a:ext cx="2066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900" dirty="0"/>
              <a:t>Fluorescence intensity per chromosome</a:t>
            </a:r>
          </a:p>
        </p:txBody>
      </p:sp>
      <p:sp>
        <p:nvSpPr>
          <p:cNvPr id="7" name="TextovéPole 6">
            <a:extLst>
              <a:ext uri="{FF2B5EF4-FFF2-40B4-BE49-F238E27FC236}">
                <a16:creationId xmlns:a16="http://schemas.microsoft.com/office/drawing/2014/main" id="{D4514320-9135-A0F0-8B47-0587AF1A8BB1}"/>
              </a:ext>
            </a:extLst>
          </p:cNvPr>
          <p:cNvSpPr txBox="1"/>
          <p:nvPr/>
        </p:nvSpPr>
        <p:spPr>
          <a:xfrm>
            <a:off x="5657850" y="5998389"/>
            <a:ext cx="7377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100" dirty="0"/>
              <a:t>p</a:t>
            </a:r>
            <a:r>
              <a:rPr lang="en-US" sz="1100" dirty="0"/>
              <a:t>&lt;</a:t>
            </a:r>
            <a:r>
              <a:rPr lang="cs-CZ" sz="1100" dirty="0"/>
              <a:t>0.05, s.</a:t>
            </a:r>
          </a:p>
        </p:txBody>
      </p:sp>
      <p:sp>
        <p:nvSpPr>
          <p:cNvPr id="4" name="TextovéPole 3">
            <a:extLst>
              <a:ext uri="{FF2B5EF4-FFF2-40B4-BE49-F238E27FC236}">
                <a16:creationId xmlns:a16="http://schemas.microsoft.com/office/drawing/2014/main" id="{40DE9497-AEBF-F960-76DA-F62EE2A35554}"/>
              </a:ext>
            </a:extLst>
          </p:cNvPr>
          <p:cNvSpPr txBox="1"/>
          <p:nvPr/>
        </p:nvSpPr>
        <p:spPr>
          <a:xfrm>
            <a:off x="688484" y="1195117"/>
            <a:ext cx="317716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cs-CZ" dirty="0"/>
              <a:t>A</a:t>
            </a:r>
          </a:p>
        </p:txBody>
      </p:sp>
      <p:sp>
        <p:nvSpPr>
          <p:cNvPr id="8" name="TextovéPole 7">
            <a:extLst>
              <a:ext uri="{FF2B5EF4-FFF2-40B4-BE49-F238E27FC236}">
                <a16:creationId xmlns:a16="http://schemas.microsoft.com/office/drawing/2014/main" id="{43A22E01-5E96-EE64-1C5E-1FBBBEA5380F}"/>
              </a:ext>
            </a:extLst>
          </p:cNvPr>
          <p:cNvSpPr txBox="1"/>
          <p:nvPr/>
        </p:nvSpPr>
        <p:spPr>
          <a:xfrm>
            <a:off x="5471596" y="1131912"/>
            <a:ext cx="6671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dirty="0">
                <a:solidFill>
                  <a:schemeClr val="bg1"/>
                </a:solidFill>
              </a:rPr>
              <a:t>H3S10p</a:t>
            </a:r>
          </a:p>
        </p:txBody>
      </p:sp>
      <p:sp>
        <p:nvSpPr>
          <p:cNvPr id="9" name="TextovéPole 8">
            <a:extLst>
              <a:ext uri="{FF2B5EF4-FFF2-40B4-BE49-F238E27FC236}">
                <a16:creationId xmlns:a16="http://schemas.microsoft.com/office/drawing/2014/main" id="{178EAC9F-16D1-3EC1-3391-ED9048452B1E}"/>
              </a:ext>
            </a:extLst>
          </p:cNvPr>
          <p:cNvSpPr txBox="1"/>
          <p:nvPr/>
        </p:nvSpPr>
        <p:spPr>
          <a:xfrm>
            <a:off x="9074802" y="1131912"/>
            <a:ext cx="663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dirty="0" err="1">
                <a:solidFill>
                  <a:schemeClr val="bg1"/>
                </a:solidFill>
              </a:rPr>
              <a:t>merged</a:t>
            </a:r>
            <a:endParaRPr lang="cs-CZ" sz="1200" dirty="0">
              <a:solidFill>
                <a:schemeClr val="bg1"/>
              </a:solidFill>
            </a:endParaRPr>
          </a:p>
        </p:txBody>
      </p:sp>
      <p:sp>
        <p:nvSpPr>
          <p:cNvPr id="11" name="TextovéPole 10">
            <a:extLst>
              <a:ext uri="{FF2B5EF4-FFF2-40B4-BE49-F238E27FC236}">
                <a16:creationId xmlns:a16="http://schemas.microsoft.com/office/drawing/2014/main" id="{658FC18C-A46F-66A1-9AD5-BD8355E3274D}"/>
              </a:ext>
            </a:extLst>
          </p:cNvPr>
          <p:cNvSpPr txBox="1"/>
          <p:nvPr/>
        </p:nvSpPr>
        <p:spPr>
          <a:xfrm>
            <a:off x="2878035" y="1129956"/>
            <a:ext cx="10407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dirty="0" err="1"/>
              <a:t>Inverted</a:t>
            </a:r>
            <a:r>
              <a:rPr lang="cs-CZ" sz="1200" dirty="0"/>
              <a:t> DAPI</a:t>
            </a:r>
          </a:p>
        </p:txBody>
      </p:sp>
      <p:sp>
        <p:nvSpPr>
          <p:cNvPr id="12" name="TextovéPole 11">
            <a:extLst>
              <a:ext uri="{FF2B5EF4-FFF2-40B4-BE49-F238E27FC236}">
                <a16:creationId xmlns:a16="http://schemas.microsoft.com/office/drawing/2014/main" id="{E8839E91-0752-2C00-5E87-3262C89B66F0}"/>
              </a:ext>
            </a:extLst>
          </p:cNvPr>
          <p:cNvSpPr txBox="1"/>
          <p:nvPr/>
        </p:nvSpPr>
        <p:spPr>
          <a:xfrm>
            <a:off x="4953000" y="6429375"/>
            <a:ext cx="5966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dirty="0"/>
              <a:t>N=209</a:t>
            </a:r>
          </a:p>
        </p:txBody>
      </p:sp>
      <p:sp>
        <p:nvSpPr>
          <p:cNvPr id="13" name="TextovéPole 12">
            <a:extLst>
              <a:ext uri="{FF2B5EF4-FFF2-40B4-BE49-F238E27FC236}">
                <a16:creationId xmlns:a16="http://schemas.microsoft.com/office/drawing/2014/main" id="{3BC4522F-3EEA-DDED-4622-68DB7635A4C5}"/>
              </a:ext>
            </a:extLst>
          </p:cNvPr>
          <p:cNvSpPr txBox="1"/>
          <p:nvPr/>
        </p:nvSpPr>
        <p:spPr>
          <a:xfrm>
            <a:off x="6661534" y="6438900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dirty="0"/>
              <a:t>N=70</a:t>
            </a:r>
          </a:p>
        </p:txBody>
      </p:sp>
    </p:spTree>
    <p:extLst>
      <p:ext uri="{BB962C8B-B14F-4D97-AF65-F5344CB8AC3E}">
        <p14:creationId xmlns:p14="http://schemas.microsoft.com/office/powerpoint/2010/main" val="2448477669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Motiv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382</TotalTime>
  <Words>88</Words>
  <Application>Microsoft Office PowerPoint</Application>
  <PresentationFormat>Širokoúhlá obrazovka</PresentationFormat>
  <Paragraphs>11</Paragraphs>
  <Slides>1</Slides>
  <Notes>1</Notes>
  <HiddenSlides>0</HiddenSlides>
  <MMClips>0</MMClips>
  <ScaleCrop>false</ScaleCrop>
  <HeadingPairs>
    <vt:vector size="6" baseType="variant">
      <vt:variant>
        <vt:lpstr>Použitá písma</vt:lpstr>
      </vt:variant>
      <vt:variant>
        <vt:i4>3</vt:i4>
      </vt:variant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Motiv Office</vt:lpstr>
      <vt:lpstr>Prezentace aplikac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LUNEROVÁ Aneta</dc:creator>
  <cp:lastModifiedBy>Aleš Kovařík</cp:lastModifiedBy>
  <cp:revision>712</cp:revision>
  <dcterms:created xsi:type="dcterms:W3CDTF">2022-01-03T14:46:27Z</dcterms:created>
  <dcterms:modified xsi:type="dcterms:W3CDTF">2023-10-11T08:04:45Z</dcterms:modified>
</cp:coreProperties>
</file>